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6" r:id="rId2"/>
    <p:sldId id="257" r:id="rId3"/>
    <p:sldId id="258" r:id="rId4"/>
    <p:sldId id="261" r:id="rId5"/>
    <p:sldId id="260" r:id="rId6"/>
    <p:sldId id="262" r:id="rId7"/>
    <p:sldId id="263" r:id="rId8"/>
    <p:sldId id="264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67" d="100"/>
          <a:sy n="67" d="100"/>
        </p:scale>
        <p:origin x="834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03E037-647A-4ED9-81E2-B8EC4B45F425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9A3C77B-894B-4DC2-8FDB-CC3F4547EC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3753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796F6D-5DB6-499C-A834-2CBDE80AECD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45859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989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5430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3579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1006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1584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7494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0269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9698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0498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5413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5246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877CD-C4EF-4A4D-A08B-63F316FA65CC}" type="datetimeFigureOut">
              <a:rPr lang="zh-CN" altLang="en-US" smtClean="0"/>
              <a:t>2022/11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C5005-2209-492F-9DEE-C2D3AB52A2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295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wmf"/><Relationship Id="rId7" Type="http://schemas.openxmlformats.org/officeDocument/2006/relationships/image" Target="../media/image6.w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5.wmf"/><Relationship Id="rId4" Type="http://schemas.openxmlformats.org/officeDocument/2006/relationships/oleObject" Target="../embeddings/oleObject5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wmf"/><Relationship Id="rId7" Type="http://schemas.openxmlformats.org/officeDocument/2006/relationships/image" Target="../media/image9.w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8.wmf"/><Relationship Id="rId4" Type="http://schemas.openxmlformats.org/officeDocument/2006/relationships/oleObject" Target="../embeddings/oleObject8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wmf"/><Relationship Id="rId7" Type="http://schemas.openxmlformats.org/officeDocument/2006/relationships/image" Target="../media/image12.w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2.bin"/><Relationship Id="rId5" Type="http://schemas.openxmlformats.org/officeDocument/2006/relationships/image" Target="../media/image11.wmf"/><Relationship Id="rId4" Type="http://schemas.openxmlformats.org/officeDocument/2006/relationships/oleObject" Target="../embeddings/oleObject11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wmf"/><Relationship Id="rId7" Type="http://schemas.openxmlformats.org/officeDocument/2006/relationships/image" Target="../media/image15.wmf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5.bin"/><Relationship Id="rId5" Type="http://schemas.openxmlformats.org/officeDocument/2006/relationships/image" Target="../media/image14.wmf"/><Relationship Id="rId4" Type="http://schemas.openxmlformats.org/officeDocument/2006/relationships/oleObject" Target="../embeddings/oleObject14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wmf"/><Relationship Id="rId7" Type="http://schemas.openxmlformats.org/officeDocument/2006/relationships/image" Target="../media/image18.wmf"/><Relationship Id="rId2" Type="http://schemas.openxmlformats.org/officeDocument/2006/relationships/oleObject" Target="../embeddings/oleObject1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8.bin"/><Relationship Id="rId5" Type="http://schemas.openxmlformats.org/officeDocument/2006/relationships/image" Target="../media/image17.wmf"/><Relationship Id="rId4" Type="http://schemas.openxmlformats.org/officeDocument/2006/relationships/oleObject" Target="../embeddings/oleObject17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wmf"/><Relationship Id="rId7" Type="http://schemas.openxmlformats.org/officeDocument/2006/relationships/image" Target="../media/image21.wmf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1.bin"/><Relationship Id="rId5" Type="http://schemas.openxmlformats.org/officeDocument/2006/relationships/image" Target="../media/image20.wmf"/><Relationship Id="rId4" Type="http://schemas.openxmlformats.org/officeDocument/2006/relationships/oleObject" Target="../embeddings/oleObject20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wmf"/><Relationship Id="rId7" Type="http://schemas.openxmlformats.org/officeDocument/2006/relationships/image" Target="../media/image24.wmf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4.bin"/><Relationship Id="rId5" Type="http://schemas.openxmlformats.org/officeDocument/2006/relationships/image" Target="../media/image23.wmf"/><Relationship Id="rId4" Type="http://schemas.openxmlformats.org/officeDocument/2006/relationships/oleObject" Target="../embeddings/oleObject2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72139" y="287080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1 C</a:t>
            </a:r>
            <a:endParaRPr lang="zh-CN" altLang="en-US" dirty="0"/>
          </a:p>
        </p:txBody>
      </p:sp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2880538" y="1378069"/>
          <a:ext cx="6120000" cy="10089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3" imgW="1752480" imgH="289440" progId="Photoshop.Image.12">
                  <p:embed/>
                </p:oleObj>
              </mc:Choice>
              <mc:Fallback>
                <p:oleObj name="Image" r:id="rId3" imgW="1752480" imgH="28944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80538" y="1378069"/>
                        <a:ext cx="6120000" cy="10089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2880538" y="2568836"/>
          <a:ext cx="6120000" cy="10089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5" imgW="1752480" imgH="289440" progId="Photoshop.Image.12">
                  <p:embed/>
                </p:oleObj>
              </mc:Choice>
              <mc:Fallback>
                <p:oleObj name="Image" r:id="rId5" imgW="1752480" imgH="28944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80538" y="2568836"/>
                        <a:ext cx="6120000" cy="10089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/>
          <p:cNvGraphicFramePr>
            <a:graphicFrameLocks noChangeAspect="1"/>
          </p:cNvGraphicFramePr>
          <p:nvPr/>
        </p:nvGraphicFramePr>
        <p:xfrm>
          <a:off x="2880538" y="3759604"/>
          <a:ext cx="6120000" cy="127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7" imgW="1752480" imgH="365760" progId="Photoshop.Image.12">
                  <p:embed/>
                </p:oleObj>
              </mc:Choice>
              <mc:Fallback>
                <p:oleObj name="Image" r:id="rId7" imgW="1752480" imgH="3657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880538" y="3759604"/>
                        <a:ext cx="6120000" cy="1275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" name="直接连接符 8"/>
          <p:cNvCxnSpPr/>
          <p:nvPr/>
        </p:nvCxnSpPr>
        <p:spPr>
          <a:xfrm flipV="1">
            <a:off x="2413588" y="1956394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/>
        </p:nvCxnSpPr>
        <p:spPr>
          <a:xfrm flipV="1">
            <a:off x="2413588" y="2945220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/>
        </p:nvCxnSpPr>
        <p:spPr>
          <a:xfrm flipV="1">
            <a:off x="2413588" y="4274291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1449138" y="1739831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1507648" y="2848977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1507648" y="399530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9303742" y="1579340"/>
            <a:ext cx="776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iNOS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9303742" y="2829279"/>
            <a:ext cx="776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X-2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9245232" y="4210493"/>
            <a:ext cx="8931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28220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33916" y="276447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2  A</a:t>
            </a:r>
            <a:endParaRPr lang="zh-CN" altLang="en-US" dirty="0"/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4798828" y="1669009"/>
          <a:ext cx="2880000" cy="1301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1222920" imgH="552960" progId="Photoshop.Image.12">
                  <p:embed/>
                </p:oleObj>
              </mc:Choice>
              <mc:Fallback>
                <p:oleObj name="Image" r:id="rId2" imgW="1222920" imgH="5529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98828" y="1669009"/>
                        <a:ext cx="2880000" cy="1301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直接连接符 7"/>
          <p:cNvCxnSpPr/>
          <p:nvPr/>
        </p:nvCxnSpPr>
        <p:spPr>
          <a:xfrm flipV="1">
            <a:off x="4018659" y="2309179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3170044" y="2209908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KD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3170044" y="3575375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0KD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3228553" y="4349120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8249951" y="2152486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ikk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8344528" y="3390709"/>
            <a:ext cx="445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ikk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8243181" y="4666817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graphicFrame>
        <p:nvGraphicFramePr>
          <p:cNvPr id="18" name="对象 17"/>
          <p:cNvGraphicFramePr>
            <a:graphicFrameLocks noChangeAspect="1"/>
          </p:cNvGraphicFramePr>
          <p:nvPr/>
        </p:nvGraphicFramePr>
        <p:xfrm>
          <a:off x="4798828" y="3273761"/>
          <a:ext cx="2880000" cy="8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761760" imgH="228600" progId="Photoshop.Image.12">
                  <p:embed/>
                </p:oleObj>
              </mc:Choice>
              <mc:Fallback>
                <p:oleObj name="Image" r:id="rId4" imgW="761760" imgH="22860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98828" y="3273761"/>
                        <a:ext cx="2880000" cy="8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9" name="直接连接符 18"/>
          <p:cNvCxnSpPr/>
          <p:nvPr/>
        </p:nvCxnSpPr>
        <p:spPr>
          <a:xfrm flipV="1">
            <a:off x="4018659" y="3760041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2" name="对象 21"/>
          <p:cNvGraphicFramePr>
            <a:graphicFrameLocks noChangeAspect="1"/>
          </p:cNvGraphicFramePr>
          <p:nvPr/>
        </p:nvGraphicFramePr>
        <p:xfrm>
          <a:off x="4798828" y="4440903"/>
          <a:ext cx="2880000" cy="77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914400" imgH="243720" progId="Photoshop.Image.12">
                  <p:embed/>
                </p:oleObj>
              </mc:Choice>
              <mc:Fallback>
                <p:oleObj name="Image" r:id="rId6" imgW="914400" imgH="24372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98828" y="4440903"/>
                        <a:ext cx="2880000" cy="77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3" name="直接连接符 22"/>
          <p:cNvCxnSpPr/>
          <p:nvPr/>
        </p:nvCxnSpPr>
        <p:spPr>
          <a:xfrm flipV="1">
            <a:off x="4018659" y="4631230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174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04037" y="401232"/>
            <a:ext cx="904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2   C</a:t>
            </a:r>
            <a:endParaRPr lang="zh-CN" altLang="en-US" dirty="0"/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4836000" y="1102980"/>
          <a:ext cx="2520000" cy="17526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1339560" imgH="931680" progId="Photoshop.Image.12">
                  <p:embed/>
                </p:oleObj>
              </mc:Choice>
              <mc:Fallback>
                <p:oleObj name="Image" r:id="rId2" imgW="1339560" imgH="93168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36000" y="1102980"/>
                        <a:ext cx="2520000" cy="17526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4836000" y="4609989"/>
          <a:ext cx="2520000" cy="1477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1339560" imgH="786240" progId="Photoshop.Image.12">
                  <p:embed/>
                </p:oleObj>
              </mc:Choice>
              <mc:Fallback>
                <p:oleObj name="Image" r:id="rId4" imgW="1339560" imgH="78624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836000" y="4609989"/>
                        <a:ext cx="2520000" cy="1477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4836000" y="3051599"/>
          <a:ext cx="2520000" cy="13597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761760" imgH="411480" progId="Photoshop.Image.12">
                  <p:embed/>
                </p:oleObj>
              </mc:Choice>
              <mc:Fallback>
                <p:oleObj name="Image" r:id="rId6" imgW="761760" imgH="41148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36000" y="3051599"/>
                        <a:ext cx="2520000" cy="13597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直接连接符 5"/>
          <p:cNvCxnSpPr/>
          <p:nvPr/>
        </p:nvCxnSpPr>
        <p:spPr>
          <a:xfrm flipV="1">
            <a:off x="4082775" y="1797279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4082775" y="3556950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4082775" y="5040087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3204906" y="1698008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3204906" y="3396940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3204906" y="4855421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7979126" y="1698008"/>
            <a:ext cx="7841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</a:t>
            </a:r>
            <a:r>
              <a:rPr lang="en-US" altLang="zh-CN" dirty="0" err="1"/>
              <a:t>ikb</a:t>
            </a:r>
            <a:r>
              <a:rPr lang="en-US" altLang="zh-CN" dirty="0"/>
              <a:t>α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8073703" y="3462669"/>
            <a:ext cx="5950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ikb</a:t>
            </a:r>
            <a:r>
              <a:rPr lang="en-US" altLang="zh-CN" dirty="0"/>
              <a:t>α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7870923" y="5128120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768871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80754" y="318977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2   E</a:t>
            </a:r>
            <a:endParaRPr lang="zh-CN" altLang="en-US" dirty="0"/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4778987" y="2850492"/>
          <a:ext cx="2880000" cy="115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761760" imgH="304560" progId="Photoshop.Image.12">
                  <p:embed/>
                </p:oleObj>
              </mc:Choice>
              <mc:Fallback>
                <p:oleObj name="Image" r:id="rId2" imgW="761760" imgH="3045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78987" y="2850492"/>
                        <a:ext cx="2880000" cy="1152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4778987" y="4249552"/>
          <a:ext cx="2880000" cy="12660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761760" imgH="335160" progId="Photoshop.Image.12">
                  <p:embed/>
                </p:oleObj>
              </mc:Choice>
              <mc:Fallback>
                <p:oleObj name="Image" r:id="rId4" imgW="761760" imgH="3351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78987" y="4249552"/>
                        <a:ext cx="2880000" cy="12660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4778987" y="1739432"/>
          <a:ext cx="2880000" cy="86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761760" imgH="228600" progId="Photoshop.Image.12">
                  <p:embed/>
                </p:oleObj>
              </mc:Choice>
              <mc:Fallback>
                <p:oleObj name="Image" r:id="rId6" imgW="761760" imgH="22860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78987" y="1739432"/>
                        <a:ext cx="2880000" cy="86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直接连接符 5"/>
          <p:cNvCxnSpPr/>
          <p:nvPr/>
        </p:nvCxnSpPr>
        <p:spPr>
          <a:xfrm flipV="1">
            <a:off x="3853954" y="1828071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3949648" y="3043380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3715731" y="4594943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837862" y="1739432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2853381" y="2921499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837862" y="4472899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8219176" y="2068442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65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8313753" y="3435175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65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8149445" y="4842231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69931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4534563" y="2735001"/>
          <a:ext cx="2880000" cy="9869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2038320" imgH="698760" progId="Photoshop.Image.12">
                  <p:embed/>
                </p:oleObj>
              </mc:Choice>
              <mc:Fallback>
                <p:oleObj name="Image" r:id="rId2" imgW="2038320" imgH="6987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534563" y="2735001"/>
                        <a:ext cx="2880000" cy="9869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4534563" y="4003195"/>
          <a:ext cx="2880000" cy="1255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1601640" imgH="698760" progId="Photoshop.Image.12">
                  <p:embed/>
                </p:oleObj>
              </mc:Choice>
              <mc:Fallback>
                <p:oleObj name="Image" r:id="rId4" imgW="1601640" imgH="6987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534563" y="4003195"/>
                        <a:ext cx="2880000" cy="12558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4534563" y="1197825"/>
          <a:ext cx="2880000" cy="1255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1601640" imgH="698760" progId="Photoshop.Image.12">
                  <p:embed/>
                </p:oleObj>
              </mc:Choice>
              <mc:Fallback>
                <p:oleObj name="Image" r:id="rId6" imgW="1601640" imgH="6987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34563" y="1197825"/>
                        <a:ext cx="2880000" cy="12558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574159" y="223284"/>
            <a:ext cx="90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3   B</a:t>
            </a:r>
            <a:endParaRPr lang="zh-CN" altLang="en-US" dirty="0"/>
          </a:p>
        </p:txBody>
      </p:sp>
      <p:cxnSp>
        <p:nvCxnSpPr>
          <p:cNvPr id="6" name="直接连接符 5"/>
          <p:cNvCxnSpPr/>
          <p:nvPr/>
        </p:nvCxnSpPr>
        <p:spPr>
          <a:xfrm flipV="1">
            <a:off x="3518929" y="1798816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直接连接符 6"/>
          <p:cNvCxnSpPr/>
          <p:nvPr/>
        </p:nvCxnSpPr>
        <p:spPr>
          <a:xfrm flipV="1">
            <a:off x="3518929" y="3062428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3518929" y="4315405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611804" y="1699545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10" name="文本框 9"/>
          <p:cNvSpPr txBox="1"/>
          <p:nvPr/>
        </p:nvSpPr>
        <p:spPr>
          <a:xfrm>
            <a:off x="2728824" y="2888397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773604" y="414137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7762528" y="1758868"/>
            <a:ext cx="776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iNOS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7762528" y="3008807"/>
            <a:ext cx="776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X-2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7704018" y="4390021"/>
            <a:ext cx="8931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409086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93405" y="297711"/>
            <a:ext cx="893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3   E</a:t>
            </a:r>
            <a:endParaRPr lang="zh-CN" altLang="en-US" dirty="0"/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4789746" y="2612418"/>
          <a:ext cx="2880000" cy="1233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2038320" imgH="873360" progId="Photoshop.Image.12">
                  <p:embed/>
                </p:oleObj>
              </mc:Choice>
              <mc:Fallback>
                <p:oleObj name="Image" r:id="rId2" imgW="2038320" imgH="8733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89746" y="2612418"/>
                        <a:ext cx="2880000" cy="12336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4789746" y="1279007"/>
          <a:ext cx="2880000" cy="1233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2038320" imgH="873360" progId="Photoshop.Image.12">
                  <p:embed/>
                </p:oleObj>
              </mc:Choice>
              <mc:Fallback>
                <p:oleObj name="Image" r:id="rId4" imgW="2038320" imgH="8733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89746" y="1279007"/>
                        <a:ext cx="2880000" cy="12336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" name="直接连接符 10"/>
          <p:cNvCxnSpPr/>
          <p:nvPr/>
        </p:nvCxnSpPr>
        <p:spPr>
          <a:xfrm flipV="1">
            <a:off x="3822184" y="1711113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 flipV="1">
            <a:off x="3822184" y="2926422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2710398" y="162247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2725917" y="2804541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2781055" y="3986608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7" name="文本框 16"/>
          <p:cNvSpPr txBox="1"/>
          <p:nvPr/>
        </p:nvSpPr>
        <p:spPr>
          <a:xfrm>
            <a:off x="8003315" y="1620375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-p65</a:t>
            </a:r>
            <a:endParaRPr lang="zh-CN" altLang="en-US" dirty="0"/>
          </a:p>
        </p:txBody>
      </p:sp>
      <p:sp>
        <p:nvSpPr>
          <p:cNvPr id="18" name="文本框 17"/>
          <p:cNvSpPr txBox="1"/>
          <p:nvPr/>
        </p:nvSpPr>
        <p:spPr>
          <a:xfrm>
            <a:off x="8097892" y="2987108"/>
            <a:ext cx="540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p65</a:t>
            </a:r>
            <a:endParaRPr lang="zh-CN" altLang="en-US" dirty="0"/>
          </a:p>
        </p:txBody>
      </p:sp>
      <p:sp>
        <p:nvSpPr>
          <p:cNvPr id="19" name="文本框 18"/>
          <p:cNvSpPr txBox="1"/>
          <p:nvPr/>
        </p:nvSpPr>
        <p:spPr>
          <a:xfrm>
            <a:off x="7933584" y="4394164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4789746" y="3986608"/>
          <a:ext cx="2880000" cy="149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731520" imgH="380880" progId="Photoshop.Image.12">
                  <p:embed/>
                </p:oleObj>
              </mc:Choice>
              <mc:Fallback>
                <p:oleObj name="Image" r:id="rId6" imgW="731520" imgH="38088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89746" y="3986608"/>
                        <a:ext cx="2880000" cy="149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1" name="直接连接符 20"/>
          <p:cNvCxnSpPr/>
          <p:nvPr/>
        </p:nvCxnSpPr>
        <p:spPr>
          <a:xfrm flipV="1">
            <a:off x="3822184" y="4284613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577991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0606162"/>
              </p:ext>
            </p:extLst>
          </p:nvPr>
        </p:nvGraphicFramePr>
        <p:xfrm>
          <a:off x="4656000" y="2643332"/>
          <a:ext cx="2880000" cy="154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624600" imgH="335160" progId="Photoshop.Image.12">
                  <p:embed/>
                </p:oleObj>
              </mc:Choice>
              <mc:Fallback>
                <p:oleObj name="Image" r:id="rId2" imgW="624600" imgH="33516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56000" y="2643332"/>
                        <a:ext cx="2880000" cy="1546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4656000" y="4470288"/>
          <a:ext cx="2880000" cy="1758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624600" imgH="380880" progId="Photoshop.Image.12">
                  <p:embed/>
                </p:oleObj>
              </mc:Choice>
              <mc:Fallback>
                <p:oleObj name="Image" r:id="rId4" imgW="624600" imgH="38088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56000" y="4470288"/>
                        <a:ext cx="2880000" cy="1758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0853533"/>
              </p:ext>
            </p:extLst>
          </p:nvPr>
        </p:nvGraphicFramePr>
        <p:xfrm>
          <a:off x="4656000" y="736562"/>
          <a:ext cx="2880000" cy="17587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624600" imgH="380880" progId="Photoshop.Image.12">
                  <p:embed/>
                </p:oleObj>
              </mc:Choice>
              <mc:Fallback>
                <p:oleObj name="Image" r:id="rId6" imgW="624600" imgH="38088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56000" y="736562"/>
                        <a:ext cx="2880000" cy="17587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文本框 5"/>
          <p:cNvSpPr txBox="1"/>
          <p:nvPr/>
        </p:nvSpPr>
        <p:spPr>
          <a:xfrm>
            <a:off x="372140" y="212651"/>
            <a:ext cx="904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4   C</a:t>
            </a:r>
            <a:endParaRPr lang="zh-CN" altLang="en-US" dirty="0"/>
          </a:p>
        </p:txBody>
      </p:sp>
      <p:cxnSp>
        <p:nvCxnSpPr>
          <p:cNvPr id="7" name="直接连接符 6"/>
          <p:cNvCxnSpPr/>
          <p:nvPr/>
        </p:nvCxnSpPr>
        <p:spPr>
          <a:xfrm flipV="1">
            <a:off x="3667173" y="3613636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 flipV="1">
            <a:off x="3667173" y="1322654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 flipV="1">
            <a:off x="3667173" y="5339043"/>
            <a:ext cx="1063256" cy="1063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2831961" y="3439605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35KD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2831961" y="1094644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5KD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2831961" y="5068985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8284322" y="3518672"/>
            <a:ext cx="11509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sepase3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7934162" y="1333289"/>
            <a:ext cx="18512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leved-casepase3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8425226" y="5165012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214431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850605" y="318977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 5  B</a:t>
            </a:r>
            <a:endParaRPr lang="zh-CN" altLang="en-US" dirty="0"/>
          </a:p>
        </p:txBody>
      </p:sp>
      <p:cxnSp>
        <p:nvCxnSpPr>
          <p:cNvPr id="16" name="直接连接符 15"/>
          <p:cNvCxnSpPr/>
          <p:nvPr/>
        </p:nvCxnSpPr>
        <p:spPr>
          <a:xfrm flipH="1">
            <a:off x="4476306" y="1722475"/>
            <a:ext cx="10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 flipH="1">
            <a:off x="4476306" y="2838894"/>
            <a:ext cx="23862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 flipH="1">
            <a:off x="4476306" y="3924365"/>
            <a:ext cx="23862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/>
          <p:cNvSpPr txBox="1"/>
          <p:nvPr/>
        </p:nvSpPr>
        <p:spPr>
          <a:xfrm>
            <a:off x="3677689" y="1537809"/>
            <a:ext cx="7986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30KD</a:t>
            </a:r>
            <a:endParaRPr lang="zh-CN" altLang="en-US" dirty="0"/>
          </a:p>
        </p:txBody>
      </p:sp>
      <p:sp>
        <p:nvSpPr>
          <p:cNvPr id="20" name="文本框 19"/>
          <p:cNvSpPr txBox="1"/>
          <p:nvPr/>
        </p:nvSpPr>
        <p:spPr>
          <a:xfrm>
            <a:off x="3677689" y="2654228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1" name="文本框 20"/>
          <p:cNvSpPr txBox="1"/>
          <p:nvPr/>
        </p:nvSpPr>
        <p:spPr>
          <a:xfrm>
            <a:off x="3677689" y="3766736"/>
            <a:ext cx="681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0KD</a:t>
            </a:r>
            <a:endParaRPr lang="zh-CN" altLang="en-US" dirty="0"/>
          </a:p>
        </p:txBody>
      </p:sp>
      <p:sp>
        <p:nvSpPr>
          <p:cNvPr id="23" name="文本框 22"/>
          <p:cNvSpPr txBox="1"/>
          <p:nvPr/>
        </p:nvSpPr>
        <p:spPr>
          <a:xfrm>
            <a:off x="7543237" y="1640333"/>
            <a:ext cx="776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iNOS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7543237" y="2702130"/>
            <a:ext cx="7761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X-2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7484727" y="3912789"/>
            <a:ext cx="8931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graphicFrame>
        <p:nvGraphicFramePr>
          <p:cNvPr id="27" name="对象 26"/>
          <p:cNvGraphicFramePr>
            <a:graphicFrameLocks noChangeAspect="1"/>
          </p:cNvGraphicFramePr>
          <p:nvPr/>
        </p:nvGraphicFramePr>
        <p:xfrm>
          <a:off x="4695483" y="1358688"/>
          <a:ext cx="2520000" cy="879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2" imgW="609480" imgH="213120" progId="Photoshop.Image.12">
                  <p:embed/>
                </p:oleObj>
              </mc:Choice>
              <mc:Fallback>
                <p:oleObj name="Image" r:id="rId2" imgW="609480" imgH="21312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95483" y="1358688"/>
                        <a:ext cx="2520000" cy="879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对象 27"/>
          <p:cNvGraphicFramePr>
            <a:graphicFrameLocks noChangeAspect="1"/>
          </p:cNvGraphicFramePr>
          <p:nvPr/>
        </p:nvGraphicFramePr>
        <p:xfrm>
          <a:off x="4695483" y="2403964"/>
          <a:ext cx="2520000" cy="879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609480" imgH="213120" progId="Photoshop.Image.12">
                  <p:embed/>
                </p:oleObj>
              </mc:Choice>
              <mc:Fallback>
                <p:oleObj name="Image" r:id="rId4" imgW="609480" imgH="21312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95483" y="2403964"/>
                        <a:ext cx="2520000" cy="879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/>
          <p:cNvGraphicFramePr>
            <a:graphicFrameLocks noChangeAspect="1"/>
          </p:cNvGraphicFramePr>
          <p:nvPr/>
        </p:nvGraphicFramePr>
        <p:xfrm>
          <a:off x="4695483" y="3449241"/>
          <a:ext cx="2520000" cy="1194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6" imgW="609480" imgH="289440" progId="Photoshop.Image.12">
                  <p:embed/>
                </p:oleObj>
              </mc:Choice>
              <mc:Fallback>
                <p:oleObj name="Image" r:id="rId6" imgW="609480" imgH="289440" progId="Photoshop.Image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695483" y="3449241"/>
                        <a:ext cx="2520000" cy="1194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144924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73</Words>
  <Application>Microsoft Office PowerPoint</Application>
  <PresentationFormat>宽屏</PresentationFormat>
  <Paragraphs>57</Paragraphs>
  <Slides>8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主题</vt:lpstr>
      <vt:lpstr>Imag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 </cp:lastModifiedBy>
  <cp:revision>4</cp:revision>
  <dcterms:created xsi:type="dcterms:W3CDTF">2022-11-03T10:52:45Z</dcterms:created>
  <dcterms:modified xsi:type="dcterms:W3CDTF">2022-11-04T00:34:01Z</dcterms:modified>
</cp:coreProperties>
</file>